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media/image13.png" ContentType="image/png"/>
  <Override PartName="/ppt/media/image9.wmf" ContentType="image/x-wmf"/>
  <Override PartName="/ppt/media/image14.png" ContentType="image/png"/>
  <Override PartName="/ppt/media/image16.png" ContentType="image/png"/>
  <Override PartName="/ppt/media/image15.png" ContentType="image/png"/>
  <Override PartName="/ppt/media/image1.wmf" ContentType="image/x-wmf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2.png" ContentType="image/png"/>
  <Override PartName="/ppt/media/image7.jpeg" ContentType="image/jpeg"/>
  <Override PartName="/ppt/media/image2.png" ContentType="image/png"/>
  <Override PartName="/ppt/media/image10.wmf" ContentType="image/x-wmf"/>
  <Override PartName="/ppt/media/image6.wmf" ContentType="image/x-wmf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119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65F91-C643-4E79-B688-BEE1BEBD48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F8B35-DD6A-4E49-8963-91A09FA10D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D0CC7-B526-45D3-BD22-B2A6B60106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AD4C6-71F7-4B4A-8655-3FB3508220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F134C-55F4-48D6-95B8-A3C8844DA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A4012-7D37-4F10-8AB0-CAB7F327B1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84BFA-5F9C-429D-A8A5-1D8C9277D3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96006-0D16-48A1-BC80-A6F2939495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C4B04-4105-40E4-964A-6F752CA336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B1360-9AFE-45F0-9F0E-64489494D9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077FA-F0CB-42E4-8E36-BB70387F82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71E52-4AF7-425D-8173-3BCA4DA6A9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C32FF2-0F0D-4F81-93A3-E40E301035E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wmf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9.wmf"/><Relationship Id="rId13" Type="http://schemas.openxmlformats.org/officeDocument/2006/relationships/oleObject" Target="../embeddings/oleObject4.bin"/><Relationship Id="rId14" Type="http://schemas.openxmlformats.org/officeDocument/2006/relationships/image" Target="../media/image10.wmf"/><Relationship Id="rId15" Type="http://schemas.openxmlformats.org/officeDocument/2006/relationships/image" Target="../media/image11.png"/><Relationship Id="rId16" Type="http://schemas.openxmlformats.org/officeDocument/2006/relationships/image" Target="../media/image12.png"/><Relationship Id="rId17" Type="http://schemas.openxmlformats.org/officeDocument/2006/relationships/image" Target="../media/image13.png"/><Relationship Id="rId18" Type="http://schemas.openxmlformats.org/officeDocument/2006/relationships/image" Target="../media/image14.png"/><Relationship Id="rId19" Type="http://schemas.openxmlformats.org/officeDocument/2006/relationships/image" Target="../media/image15.png"/><Relationship Id="rId20" Type="http://schemas.openxmlformats.org/officeDocument/2006/relationships/oleObject" Target="../embeddings/oleObject5.bin"/><Relationship Id="rId21" Type="http://schemas.openxmlformats.org/officeDocument/2006/relationships/image" Target="../media/image16.pn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5000" y="2062080"/>
          <a:ext cx="1687680" cy="997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5000" y="2062080"/>
                    <a:ext cx="1687680" cy="997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5030640" y="1805040"/>
            <a:ext cx="831960" cy="51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3 kDa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3160800" y="982800"/>
            <a:ext cx="2701800" cy="1054080"/>
            <a:chOff x="3160800" y="982800"/>
            <a:chExt cx="2701800" cy="1054080"/>
          </a:xfrm>
        </p:grpSpPr>
        <p:sp>
          <p:nvSpPr>
            <p:cNvPr id="45" name=""/>
            <p:cNvSpPr/>
            <p:nvPr/>
          </p:nvSpPr>
          <p:spPr>
            <a:xfrm>
              <a:off x="3160800" y="1539720"/>
              <a:ext cx="801720" cy="48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FGFR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ß-Acti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4187160" y="500400"/>
              <a:ext cx="599760" cy="156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KD3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WT3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cDNA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030640" y="1539720"/>
              <a:ext cx="83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30 kDa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3"/>
            <a:srcRect l="23272" t="-9546" r="0" b="0"/>
            <a:stretch/>
          </p:blipFill>
          <p:spPr>
            <a:xfrm>
              <a:off x="3773520" y="1547640"/>
              <a:ext cx="1257120" cy="23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4"/>
            <a:srcRect l="10990" t="34286" r="55341" b="21457"/>
            <a:stretch/>
          </p:blipFill>
          <p:spPr>
            <a:xfrm>
              <a:off x="3773520" y="1835280"/>
              <a:ext cx="1257120" cy="201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0" name=""/>
          <p:cNvGrpSpPr/>
          <p:nvPr/>
        </p:nvGrpSpPr>
        <p:grpSpPr>
          <a:xfrm>
            <a:off x="0" y="1009800"/>
            <a:ext cx="3009960" cy="1010880"/>
            <a:chOff x="0" y="1009800"/>
            <a:chExt cx="3009960" cy="1010880"/>
          </a:xfrm>
        </p:grpSpPr>
        <p:sp>
          <p:nvSpPr>
            <p:cNvPr id="51" name=""/>
            <p:cNvSpPr/>
            <p:nvPr/>
          </p:nvSpPr>
          <p:spPr>
            <a:xfrm>
              <a:off x="0" y="1539720"/>
              <a:ext cx="1166760" cy="48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GFR3-III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r"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367000" y="1584360"/>
              <a:ext cx="642960" cy="36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100" spc="-1" strike="noStrike">
                  <a:solidFill>
                    <a:srgbClr val="000000"/>
                  </a:solidFill>
                  <a:latin typeface="Arial"/>
                </a:rPr>
                <a:t>435 bp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100" spc="-1" strike="noStrike">
                  <a:solidFill>
                    <a:srgbClr val="000000"/>
                  </a:solidFill>
                  <a:latin typeface="Arial"/>
                </a:rPr>
                <a:t>360 bp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1413360" y="648720"/>
              <a:ext cx="58896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KD3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WT3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cDNA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4" name="" descr=""/>
            <p:cNvPicPr/>
            <p:nvPr/>
          </p:nvPicPr>
          <p:blipFill>
            <a:blip r:embed="rId5"/>
            <a:srcRect l="17344" t="9624" r="6118" b="0"/>
            <a:stretch/>
          </p:blipFill>
          <p:spPr>
            <a:xfrm>
              <a:off x="1146240" y="1797120"/>
              <a:ext cx="1254240" cy="193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" descr=""/>
            <p:cNvPicPr/>
            <p:nvPr/>
          </p:nvPicPr>
          <p:blipFill>
            <a:blip r:embed="rId6"/>
            <a:srcRect l="18250" t="-17739" r="0" b="0"/>
            <a:stretch/>
          </p:blipFill>
          <p:spPr>
            <a:xfrm>
              <a:off x="1146240" y="1509840"/>
              <a:ext cx="127296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6" name=""/>
          <p:cNvSpPr/>
          <p:nvPr/>
        </p:nvSpPr>
        <p:spPr>
          <a:xfrm>
            <a:off x="3238920" y="8460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06720" y="8460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48400" y="244440"/>
            <a:ext cx="104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Figure 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404640" y="3646440"/>
          <a:ext cx="2808360" cy="18669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04640" y="3646440"/>
                    <a:ext cx="2808360" cy="1866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61" name=""/>
          <p:cNvGrpSpPr/>
          <p:nvPr/>
        </p:nvGrpSpPr>
        <p:grpSpPr>
          <a:xfrm>
            <a:off x="3573360" y="3276720"/>
            <a:ext cx="2098440" cy="1962360"/>
            <a:chOff x="3573360" y="3276720"/>
            <a:chExt cx="2098440" cy="1962360"/>
          </a:xfrm>
        </p:grpSpPr>
        <p:pic>
          <p:nvPicPr>
            <p:cNvPr id="62" name="" descr=""/>
            <p:cNvPicPr/>
            <p:nvPr/>
          </p:nvPicPr>
          <p:blipFill>
            <a:blip r:embed="rId9"/>
            <a:stretch/>
          </p:blipFill>
          <p:spPr>
            <a:xfrm>
              <a:off x="3573360" y="4419720"/>
              <a:ext cx="1378080" cy="46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10"/>
            <a:stretch/>
          </p:blipFill>
          <p:spPr>
            <a:xfrm>
              <a:off x="3645000" y="4962600"/>
              <a:ext cx="1309680" cy="24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"/>
            <p:cNvSpPr/>
            <p:nvPr/>
          </p:nvSpPr>
          <p:spPr>
            <a:xfrm>
              <a:off x="3573360" y="3570120"/>
              <a:ext cx="69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SW48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437000" y="357012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3342960" y="3914640"/>
              <a:ext cx="80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900" spc="-1" strike="noStrike">
                  <a:solidFill>
                    <a:srgbClr val="000000"/>
                  </a:solidFill>
                  <a:latin typeface="Arial"/>
                </a:rPr>
                <a:t>pcDNA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6200000">
              <a:off x="3485160" y="3739680"/>
              <a:ext cx="1157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900" spc="-1" strike="noStrike">
                  <a:solidFill>
                    <a:srgbClr val="000000"/>
                  </a:solidFill>
                  <a:latin typeface="Arial"/>
                </a:rPr>
                <a:t>KD3b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4179600" y="3740400"/>
              <a:ext cx="1152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900" spc="-1" strike="noStrike">
                  <a:solidFill>
                    <a:srgbClr val="000000"/>
                  </a:solidFill>
                  <a:latin typeface="Arial"/>
                </a:rPr>
                <a:t>KD3b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3957120" y="3914640"/>
              <a:ext cx="80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900" spc="-1" strike="noStrike">
                  <a:solidFill>
                    <a:srgbClr val="000000"/>
                  </a:solidFill>
                  <a:latin typeface="Arial"/>
                </a:rPr>
                <a:t>pcDNA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991040" y="4530600"/>
              <a:ext cx="68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FGFR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990680" y="496260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ß-acti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306360" y="32036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238920" y="32036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74" name=""/>
          <p:cNvGraphicFramePr/>
          <p:nvPr/>
        </p:nvGraphicFramePr>
        <p:xfrm>
          <a:off x="1023840" y="7464600"/>
          <a:ext cx="1697040" cy="14763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5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023840" y="7464600"/>
                    <a:ext cx="1697040" cy="147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6" name=""/>
          <p:cNvGraphicFramePr/>
          <p:nvPr/>
        </p:nvGraphicFramePr>
        <p:xfrm>
          <a:off x="3635280" y="7467480"/>
          <a:ext cx="1717920" cy="147348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77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635280" y="7467480"/>
                    <a:ext cx="1717920" cy="147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8" name=""/>
          <p:cNvSpPr/>
          <p:nvPr/>
        </p:nvSpPr>
        <p:spPr>
          <a:xfrm>
            <a:off x="3238200" y="5353200"/>
            <a:ext cx="24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9" name=""/>
          <p:cNvGrpSpPr/>
          <p:nvPr/>
        </p:nvGrpSpPr>
        <p:grpSpPr>
          <a:xfrm>
            <a:off x="3119400" y="5596200"/>
            <a:ext cx="2938680" cy="1706400"/>
            <a:chOff x="3119400" y="5596200"/>
            <a:chExt cx="2938680" cy="1706400"/>
          </a:xfrm>
        </p:grpSpPr>
        <p:sp>
          <p:nvSpPr>
            <p:cNvPr id="80" name=""/>
            <p:cNvSpPr/>
            <p:nvPr/>
          </p:nvSpPr>
          <p:spPr>
            <a:xfrm>
              <a:off x="5313240" y="6754680"/>
              <a:ext cx="744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30kDa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136680" y="7026120"/>
              <a:ext cx="66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AT" sz="1200" spc="-1" strike="noStrike">
                  <a:solidFill>
                    <a:srgbClr val="000000"/>
                  </a:solidFill>
                  <a:latin typeface="Arial"/>
                </a:rPr>
                <a:t>ß-Acti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119400" y="6780240"/>
              <a:ext cx="68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GFR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313240" y="704052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3kDa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84" name="" descr=""/>
            <p:cNvPicPr/>
            <p:nvPr/>
          </p:nvPicPr>
          <p:blipFill>
            <a:blip r:embed="rId15"/>
            <a:srcRect l="140" t="12261" r="0" b="13863"/>
            <a:stretch/>
          </p:blipFill>
          <p:spPr>
            <a:xfrm>
              <a:off x="3732120" y="7081920"/>
              <a:ext cx="162396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" descr=""/>
            <p:cNvPicPr/>
            <p:nvPr/>
          </p:nvPicPr>
          <p:blipFill>
            <a:blip r:embed="rId16"/>
            <a:srcRect l="2788" t="9864" r="2788" b="57377"/>
            <a:stretch/>
          </p:blipFill>
          <p:spPr>
            <a:xfrm>
              <a:off x="3732120" y="6786720"/>
              <a:ext cx="1621080" cy="236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"/>
            <p:cNvSpPr/>
            <p:nvPr/>
          </p:nvSpPr>
          <p:spPr>
            <a:xfrm rot="10768200">
              <a:off x="3716640" y="5600520"/>
              <a:ext cx="216720" cy="114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0768200">
              <a:off x="3985200" y="5601600"/>
              <a:ext cx="216720" cy="114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 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0768200">
              <a:off x="4259520" y="5601600"/>
              <a:ext cx="216720" cy="114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 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0767600">
              <a:off x="4527720" y="5603040"/>
              <a:ext cx="216720" cy="1150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MOI GFP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0767600">
              <a:off x="5067360" y="5596920"/>
              <a:ext cx="21672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U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0767600">
              <a:off x="4797360" y="5603040"/>
              <a:ext cx="216720" cy="1150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 MOI GFP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306720" y="5353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0" y="5175360"/>
            <a:ext cx="3276720" cy="2230200"/>
            <a:chOff x="0" y="5175360"/>
            <a:chExt cx="3276720" cy="2230200"/>
          </a:xfrm>
        </p:grpSpPr>
        <p:sp>
          <p:nvSpPr>
            <p:cNvPr id="94" name=""/>
            <p:cNvSpPr/>
            <p:nvPr/>
          </p:nvSpPr>
          <p:spPr>
            <a:xfrm>
              <a:off x="0" y="6253200"/>
              <a:ext cx="1141560" cy="1110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GFR3-IIIb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GFR3-III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GFR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598840" y="6161040"/>
              <a:ext cx="677880" cy="124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29b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35b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31b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60b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96" name="" descr=""/>
            <p:cNvPicPr/>
            <p:nvPr/>
          </p:nvPicPr>
          <p:blipFill>
            <a:blip r:embed="rId17"/>
            <a:stretch/>
          </p:blipFill>
          <p:spPr>
            <a:xfrm>
              <a:off x="1139760" y="6272280"/>
              <a:ext cx="152244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" descr=""/>
            <p:cNvPicPr/>
            <p:nvPr/>
          </p:nvPicPr>
          <p:blipFill>
            <a:blip r:embed="rId18"/>
            <a:stretch/>
          </p:blipFill>
          <p:spPr>
            <a:xfrm>
              <a:off x="1139760" y="6576840"/>
              <a:ext cx="1522440" cy="22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" descr=""/>
            <p:cNvPicPr/>
            <p:nvPr/>
          </p:nvPicPr>
          <p:blipFill>
            <a:blip r:embed="rId19"/>
            <a:stretch/>
          </p:blipFill>
          <p:spPr>
            <a:xfrm>
              <a:off x="1139760" y="6881760"/>
              <a:ext cx="1522440" cy="22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"/>
            <p:cNvSpPr/>
            <p:nvPr/>
          </p:nvSpPr>
          <p:spPr>
            <a:xfrm rot="10768200">
              <a:off x="1195920" y="5179320"/>
              <a:ext cx="216720" cy="10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10768200">
              <a:off x="1500480" y="5176080"/>
              <a:ext cx="216720" cy="10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0768200">
              <a:off x="1797480" y="5190840"/>
              <a:ext cx="216720" cy="10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MOI KD3-IIIc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0767600">
              <a:off x="2102040" y="5189040"/>
              <a:ext cx="216720" cy="1092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MOI GFP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0767600">
              <a:off x="2405160" y="5180760"/>
              <a:ext cx="216720" cy="10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 vert="eaVert">
              <a:spAutoFit/>
            </a:bodyPr>
            <a:p>
              <a:pPr>
                <a:lnSpc>
                  <a:spcPct val="30000"/>
                </a:lnSpc>
                <a:spcBef>
                  <a:spcPts val="499"/>
                </a:spcBef>
                <a:spcAft>
                  <a:spcPts val="7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U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104" name=""/>
            <p:cNvGraphicFramePr/>
            <p:nvPr/>
          </p:nvGraphicFramePr>
          <p:xfrm>
            <a:off x="1141560" y="7186680"/>
            <a:ext cx="1512720" cy="209520"/>
          </p:xfrm>
          <a:graphic>
            <a:graphicData uri="http://schemas.openxmlformats.org/presentationml/2006/ole">
              <p:oleObj r:id="rId20" spid="">
                <p:embed/>
                <p:pic>
                  <p:nvPicPr>
                    <p:cNvPr id="105" name="" descr=""/>
                    <p:cNvPicPr/>
                    <p:nvPr/>
                  </p:nvPicPr>
                  <p:blipFill>
                    <a:blip r:embed="rId21"/>
                    <a:stretch/>
                  </p:blipFill>
                  <p:spPr>
                    <a:xfrm>
                      <a:off x="1141560" y="7186680"/>
                      <a:ext cx="1512720" cy="20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08T06:44:15Z</dcterms:created>
  <dc:creator>Brigitte Marian</dc:creator>
  <dc:description/>
  <dc:language>en-US</dc:language>
  <cp:lastModifiedBy>Brigitte Marian</cp:lastModifiedBy>
  <dcterms:modified xsi:type="dcterms:W3CDTF">2010-01-28T09:59:11Z</dcterms:modified>
  <cp:revision>26</cp:revision>
  <dc:subject/>
  <dc:title>PowerPoint-Präsentation</dc:title>
</cp:coreProperties>
</file>